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" saveSubsetFonts="1">
  <p:sldMasterIdLst>
    <p:sldMasterId id="2147483660" r:id="rId1"/>
  </p:sldMasterIdLst>
  <p:sldIdLst>
    <p:sldId id="257" r:id="rId2"/>
  </p:sldIdLst>
  <p:sldSz cx="13258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DDD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2" d="100"/>
          <a:sy n="72" d="100"/>
        </p:scale>
        <p:origin x="-912" y="-96"/>
      </p:cViewPr>
      <p:guideLst>
        <p:guide orient="horz" pos="2592"/>
        <p:guide pos="41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57350" y="1346836"/>
            <a:ext cx="9944100" cy="2865120"/>
          </a:xfrm>
        </p:spPr>
        <p:txBody>
          <a:bodyPr anchor="b"/>
          <a:lstStyle>
            <a:lvl1pPr algn="ctr">
              <a:defRPr sz="652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7350" y="4322446"/>
            <a:ext cx="9944100" cy="1986914"/>
          </a:xfrm>
        </p:spPr>
        <p:txBody>
          <a:bodyPr/>
          <a:lstStyle>
            <a:lvl1pPr marL="0" indent="0" algn="ctr">
              <a:buNone/>
              <a:defRPr sz="2610"/>
            </a:lvl1pPr>
            <a:lvl2pPr marL="497205" indent="0" algn="ctr">
              <a:buNone/>
              <a:defRPr sz="2175"/>
            </a:lvl2pPr>
            <a:lvl3pPr marL="994410" indent="0" algn="ctr">
              <a:buNone/>
              <a:defRPr sz="1958"/>
            </a:lvl3pPr>
            <a:lvl4pPr marL="1491615" indent="0" algn="ctr">
              <a:buNone/>
              <a:defRPr sz="1740"/>
            </a:lvl4pPr>
            <a:lvl5pPr marL="1988820" indent="0" algn="ctr">
              <a:buNone/>
              <a:defRPr sz="1740"/>
            </a:lvl5pPr>
            <a:lvl6pPr marL="2486025" indent="0" algn="ctr">
              <a:buNone/>
              <a:defRPr sz="1740"/>
            </a:lvl6pPr>
            <a:lvl7pPr marL="2983230" indent="0" algn="ctr">
              <a:buNone/>
              <a:defRPr sz="1740"/>
            </a:lvl7pPr>
            <a:lvl8pPr marL="3480435" indent="0" algn="ctr">
              <a:buNone/>
              <a:defRPr sz="1740"/>
            </a:lvl8pPr>
            <a:lvl9pPr marL="3977640" indent="0" algn="ctr">
              <a:buNone/>
              <a:defRPr sz="174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490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435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88329" y="438150"/>
            <a:ext cx="2858929" cy="697420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1543" y="438150"/>
            <a:ext cx="8411051" cy="697420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482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245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4637" y="2051686"/>
            <a:ext cx="11435715" cy="3423284"/>
          </a:xfrm>
        </p:spPr>
        <p:txBody>
          <a:bodyPr anchor="b"/>
          <a:lstStyle>
            <a:lvl1pPr>
              <a:defRPr sz="652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4637" y="5507356"/>
            <a:ext cx="11435715" cy="1800224"/>
          </a:xfrm>
        </p:spPr>
        <p:txBody>
          <a:bodyPr/>
          <a:lstStyle>
            <a:lvl1pPr marL="0" indent="0">
              <a:buNone/>
              <a:defRPr sz="2610">
                <a:solidFill>
                  <a:schemeClr val="tx1">
                    <a:tint val="75000"/>
                  </a:schemeClr>
                </a:solidFill>
              </a:defRPr>
            </a:lvl1pPr>
            <a:lvl2pPr marL="497205" indent="0">
              <a:buNone/>
              <a:defRPr sz="2175">
                <a:solidFill>
                  <a:schemeClr val="tx1">
                    <a:tint val="75000"/>
                  </a:schemeClr>
                </a:solidFill>
              </a:defRPr>
            </a:lvl2pPr>
            <a:lvl3pPr marL="994410" indent="0">
              <a:buNone/>
              <a:defRPr sz="1958">
                <a:solidFill>
                  <a:schemeClr val="tx1">
                    <a:tint val="75000"/>
                  </a:schemeClr>
                </a:solidFill>
              </a:defRPr>
            </a:lvl3pPr>
            <a:lvl4pPr marL="1491615" indent="0">
              <a:buNone/>
              <a:defRPr sz="1740">
                <a:solidFill>
                  <a:schemeClr val="tx1">
                    <a:tint val="75000"/>
                  </a:schemeClr>
                </a:solidFill>
              </a:defRPr>
            </a:lvl4pPr>
            <a:lvl5pPr marL="1988820" indent="0">
              <a:buNone/>
              <a:defRPr sz="1740">
                <a:solidFill>
                  <a:schemeClr val="tx1">
                    <a:tint val="75000"/>
                  </a:schemeClr>
                </a:solidFill>
              </a:defRPr>
            </a:lvl5pPr>
            <a:lvl6pPr marL="2486025" indent="0">
              <a:buNone/>
              <a:defRPr sz="1740">
                <a:solidFill>
                  <a:schemeClr val="tx1">
                    <a:tint val="75000"/>
                  </a:schemeClr>
                </a:solidFill>
              </a:defRPr>
            </a:lvl6pPr>
            <a:lvl7pPr marL="2983230" indent="0">
              <a:buNone/>
              <a:defRPr sz="1740">
                <a:solidFill>
                  <a:schemeClr val="tx1">
                    <a:tint val="75000"/>
                  </a:schemeClr>
                </a:solidFill>
              </a:defRPr>
            </a:lvl7pPr>
            <a:lvl8pPr marL="3480435" indent="0">
              <a:buNone/>
              <a:defRPr sz="1740">
                <a:solidFill>
                  <a:schemeClr val="tx1">
                    <a:tint val="75000"/>
                  </a:schemeClr>
                </a:solidFill>
              </a:defRPr>
            </a:lvl8pPr>
            <a:lvl9pPr marL="3977640" indent="0">
              <a:buNone/>
              <a:defRPr sz="17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847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1543" y="2190750"/>
            <a:ext cx="5634990" cy="522160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12268" y="2190750"/>
            <a:ext cx="5634990" cy="522160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188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269" y="438150"/>
            <a:ext cx="11435715" cy="159067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3270" y="2017396"/>
            <a:ext cx="5609093" cy="988694"/>
          </a:xfrm>
        </p:spPr>
        <p:txBody>
          <a:bodyPr anchor="b"/>
          <a:lstStyle>
            <a:lvl1pPr marL="0" indent="0">
              <a:buNone/>
              <a:defRPr sz="2610" b="1"/>
            </a:lvl1pPr>
            <a:lvl2pPr marL="497205" indent="0">
              <a:buNone/>
              <a:defRPr sz="2175" b="1"/>
            </a:lvl2pPr>
            <a:lvl3pPr marL="994410" indent="0">
              <a:buNone/>
              <a:defRPr sz="1958" b="1"/>
            </a:lvl3pPr>
            <a:lvl4pPr marL="1491615" indent="0">
              <a:buNone/>
              <a:defRPr sz="1740" b="1"/>
            </a:lvl4pPr>
            <a:lvl5pPr marL="1988820" indent="0">
              <a:buNone/>
              <a:defRPr sz="1740" b="1"/>
            </a:lvl5pPr>
            <a:lvl6pPr marL="2486025" indent="0">
              <a:buNone/>
              <a:defRPr sz="1740" b="1"/>
            </a:lvl6pPr>
            <a:lvl7pPr marL="2983230" indent="0">
              <a:buNone/>
              <a:defRPr sz="1740" b="1"/>
            </a:lvl7pPr>
            <a:lvl8pPr marL="3480435" indent="0">
              <a:buNone/>
              <a:defRPr sz="1740" b="1"/>
            </a:lvl8pPr>
            <a:lvl9pPr marL="3977640" indent="0">
              <a:buNone/>
              <a:defRPr sz="174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3270" y="3006090"/>
            <a:ext cx="5609093" cy="442150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12267" y="2017396"/>
            <a:ext cx="5636717" cy="988694"/>
          </a:xfrm>
        </p:spPr>
        <p:txBody>
          <a:bodyPr anchor="b"/>
          <a:lstStyle>
            <a:lvl1pPr marL="0" indent="0">
              <a:buNone/>
              <a:defRPr sz="2610" b="1"/>
            </a:lvl1pPr>
            <a:lvl2pPr marL="497205" indent="0">
              <a:buNone/>
              <a:defRPr sz="2175" b="1"/>
            </a:lvl2pPr>
            <a:lvl3pPr marL="994410" indent="0">
              <a:buNone/>
              <a:defRPr sz="1958" b="1"/>
            </a:lvl3pPr>
            <a:lvl4pPr marL="1491615" indent="0">
              <a:buNone/>
              <a:defRPr sz="1740" b="1"/>
            </a:lvl4pPr>
            <a:lvl5pPr marL="1988820" indent="0">
              <a:buNone/>
              <a:defRPr sz="1740" b="1"/>
            </a:lvl5pPr>
            <a:lvl6pPr marL="2486025" indent="0">
              <a:buNone/>
              <a:defRPr sz="1740" b="1"/>
            </a:lvl6pPr>
            <a:lvl7pPr marL="2983230" indent="0">
              <a:buNone/>
              <a:defRPr sz="1740" b="1"/>
            </a:lvl7pPr>
            <a:lvl8pPr marL="3480435" indent="0">
              <a:buNone/>
              <a:defRPr sz="1740" b="1"/>
            </a:lvl8pPr>
            <a:lvl9pPr marL="3977640" indent="0">
              <a:buNone/>
              <a:defRPr sz="174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12267" y="3006090"/>
            <a:ext cx="5636717" cy="442150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3918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77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30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270" y="548640"/>
            <a:ext cx="4276308" cy="1920240"/>
          </a:xfrm>
        </p:spPr>
        <p:txBody>
          <a:bodyPr anchor="b"/>
          <a:lstStyle>
            <a:lvl1pPr>
              <a:defRPr sz="348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36717" y="1184911"/>
            <a:ext cx="6712268" cy="5848350"/>
          </a:xfrm>
        </p:spPr>
        <p:txBody>
          <a:bodyPr/>
          <a:lstStyle>
            <a:lvl1pPr>
              <a:defRPr sz="3480"/>
            </a:lvl1pPr>
            <a:lvl2pPr>
              <a:defRPr sz="3045"/>
            </a:lvl2pPr>
            <a:lvl3pPr>
              <a:defRPr sz="2610"/>
            </a:lvl3pPr>
            <a:lvl4pPr>
              <a:defRPr sz="2175"/>
            </a:lvl4pPr>
            <a:lvl5pPr>
              <a:defRPr sz="2175"/>
            </a:lvl5pPr>
            <a:lvl6pPr>
              <a:defRPr sz="2175"/>
            </a:lvl6pPr>
            <a:lvl7pPr>
              <a:defRPr sz="2175"/>
            </a:lvl7pPr>
            <a:lvl8pPr>
              <a:defRPr sz="2175"/>
            </a:lvl8pPr>
            <a:lvl9pPr>
              <a:defRPr sz="2175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270" y="2468880"/>
            <a:ext cx="4276308" cy="4573906"/>
          </a:xfrm>
        </p:spPr>
        <p:txBody>
          <a:bodyPr/>
          <a:lstStyle>
            <a:lvl1pPr marL="0" indent="0">
              <a:buNone/>
              <a:defRPr sz="1740"/>
            </a:lvl1pPr>
            <a:lvl2pPr marL="497205" indent="0">
              <a:buNone/>
              <a:defRPr sz="1523"/>
            </a:lvl2pPr>
            <a:lvl3pPr marL="994410" indent="0">
              <a:buNone/>
              <a:defRPr sz="1305"/>
            </a:lvl3pPr>
            <a:lvl4pPr marL="1491615" indent="0">
              <a:buNone/>
              <a:defRPr sz="1088"/>
            </a:lvl4pPr>
            <a:lvl5pPr marL="1988820" indent="0">
              <a:buNone/>
              <a:defRPr sz="1088"/>
            </a:lvl5pPr>
            <a:lvl6pPr marL="2486025" indent="0">
              <a:buNone/>
              <a:defRPr sz="1088"/>
            </a:lvl6pPr>
            <a:lvl7pPr marL="2983230" indent="0">
              <a:buNone/>
              <a:defRPr sz="1088"/>
            </a:lvl7pPr>
            <a:lvl8pPr marL="3480435" indent="0">
              <a:buNone/>
              <a:defRPr sz="1088"/>
            </a:lvl8pPr>
            <a:lvl9pPr marL="3977640" indent="0">
              <a:buNone/>
              <a:defRPr sz="1088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934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270" y="548640"/>
            <a:ext cx="4276308" cy="1920240"/>
          </a:xfrm>
        </p:spPr>
        <p:txBody>
          <a:bodyPr anchor="b"/>
          <a:lstStyle>
            <a:lvl1pPr>
              <a:defRPr sz="348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36717" y="1184911"/>
            <a:ext cx="6712268" cy="5848350"/>
          </a:xfrm>
        </p:spPr>
        <p:txBody>
          <a:bodyPr anchor="t"/>
          <a:lstStyle>
            <a:lvl1pPr marL="0" indent="0">
              <a:buNone/>
              <a:defRPr sz="3480"/>
            </a:lvl1pPr>
            <a:lvl2pPr marL="497205" indent="0">
              <a:buNone/>
              <a:defRPr sz="3045"/>
            </a:lvl2pPr>
            <a:lvl3pPr marL="994410" indent="0">
              <a:buNone/>
              <a:defRPr sz="2610"/>
            </a:lvl3pPr>
            <a:lvl4pPr marL="1491615" indent="0">
              <a:buNone/>
              <a:defRPr sz="2175"/>
            </a:lvl4pPr>
            <a:lvl5pPr marL="1988820" indent="0">
              <a:buNone/>
              <a:defRPr sz="2175"/>
            </a:lvl5pPr>
            <a:lvl6pPr marL="2486025" indent="0">
              <a:buNone/>
              <a:defRPr sz="2175"/>
            </a:lvl6pPr>
            <a:lvl7pPr marL="2983230" indent="0">
              <a:buNone/>
              <a:defRPr sz="2175"/>
            </a:lvl7pPr>
            <a:lvl8pPr marL="3480435" indent="0">
              <a:buNone/>
              <a:defRPr sz="2175"/>
            </a:lvl8pPr>
            <a:lvl9pPr marL="3977640" indent="0">
              <a:buNone/>
              <a:defRPr sz="2175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270" y="2468880"/>
            <a:ext cx="4276308" cy="4573906"/>
          </a:xfrm>
        </p:spPr>
        <p:txBody>
          <a:bodyPr/>
          <a:lstStyle>
            <a:lvl1pPr marL="0" indent="0">
              <a:buNone/>
              <a:defRPr sz="1740"/>
            </a:lvl1pPr>
            <a:lvl2pPr marL="497205" indent="0">
              <a:buNone/>
              <a:defRPr sz="1523"/>
            </a:lvl2pPr>
            <a:lvl3pPr marL="994410" indent="0">
              <a:buNone/>
              <a:defRPr sz="1305"/>
            </a:lvl3pPr>
            <a:lvl4pPr marL="1491615" indent="0">
              <a:buNone/>
              <a:defRPr sz="1088"/>
            </a:lvl4pPr>
            <a:lvl5pPr marL="1988820" indent="0">
              <a:buNone/>
              <a:defRPr sz="1088"/>
            </a:lvl5pPr>
            <a:lvl6pPr marL="2486025" indent="0">
              <a:buNone/>
              <a:defRPr sz="1088"/>
            </a:lvl6pPr>
            <a:lvl7pPr marL="2983230" indent="0">
              <a:buNone/>
              <a:defRPr sz="1088"/>
            </a:lvl7pPr>
            <a:lvl8pPr marL="3480435" indent="0">
              <a:buNone/>
              <a:defRPr sz="1088"/>
            </a:lvl8pPr>
            <a:lvl9pPr marL="3977640" indent="0">
              <a:buNone/>
              <a:defRPr sz="1088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964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1543" y="438150"/>
            <a:ext cx="1143571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1543" y="2190750"/>
            <a:ext cx="1143571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1543" y="7627621"/>
            <a:ext cx="298323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C2F4E-EB97-4140-BBCD-65C4529BA48C}" type="datetimeFigureOut">
              <a:rPr lang="en-US" smtClean="0"/>
              <a:t>9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91978" y="7627621"/>
            <a:ext cx="447484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64028" y="7627621"/>
            <a:ext cx="298323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6E525-ABE8-4B86-A72D-EA78A1668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609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94410" rtl="0" eaLnBrk="1" latinLnBrk="0" hangingPunct="1">
        <a:lnSpc>
          <a:spcPct val="90000"/>
        </a:lnSpc>
        <a:spcBef>
          <a:spcPct val="0"/>
        </a:spcBef>
        <a:buNone/>
        <a:defRPr sz="47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8603" indent="-248603" algn="l" defTabSz="994410" rtl="0" eaLnBrk="1" latinLnBrk="0" hangingPunct="1">
        <a:lnSpc>
          <a:spcPct val="90000"/>
        </a:lnSpc>
        <a:spcBef>
          <a:spcPts val="1088"/>
        </a:spcBef>
        <a:buFont typeface="Arial" panose="020B0604020202020204" pitchFamily="34" charset="0"/>
        <a:buChar char="•"/>
        <a:defRPr sz="3045" kern="1200">
          <a:solidFill>
            <a:schemeClr val="tx1"/>
          </a:solidFill>
          <a:latin typeface="+mn-lt"/>
          <a:ea typeface="+mn-ea"/>
          <a:cs typeface="+mn-cs"/>
        </a:defRPr>
      </a:lvl1pPr>
      <a:lvl2pPr marL="745808" indent="-248603" algn="l" defTabSz="994410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2610" kern="1200">
          <a:solidFill>
            <a:schemeClr val="tx1"/>
          </a:solidFill>
          <a:latin typeface="+mn-lt"/>
          <a:ea typeface="+mn-ea"/>
          <a:cs typeface="+mn-cs"/>
        </a:defRPr>
      </a:lvl2pPr>
      <a:lvl3pPr marL="1243013" indent="-248603" algn="l" defTabSz="994410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2175" kern="1200">
          <a:solidFill>
            <a:schemeClr val="tx1"/>
          </a:solidFill>
          <a:latin typeface="+mn-lt"/>
          <a:ea typeface="+mn-ea"/>
          <a:cs typeface="+mn-cs"/>
        </a:defRPr>
      </a:lvl3pPr>
      <a:lvl4pPr marL="1740218" indent="-248603" algn="l" defTabSz="994410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8" kern="1200">
          <a:solidFill>
            <a:schemeClr val="tx1"/>
          </a:solidFill>
          <a:latin typeface="+mn-lt"/>
          <a:ea typeface="+mn-ea"/>
          <a:cs typeface="+mn-cs"/>
        </a:defRPr>
      </a:lvl4pPr>
      <a:lvl5pPr marL="2237423" indent="-248603" algn="l" defTabSz="994410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8" kern="1200">
          <a:solidFill>
            <a:schemeClr val="tx1"/>
          </a:solidFill>
          <a:latin typeface="+mn-lt"/>
          <a:ea typeface="+mn-ea"/>
          <a:cs typeface="+mn-cs"/>
        </a:defRPr>
      </a:lvl5pPr>
      <a:lvl6pPr marL="2734628" indent="-248603" algn="l" defTabSz="994410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8" kern="1200">
          <a:solidFill>
            <a:schemeClr val="tx1"/>
          </a:solidFill>
          <a:latin typeface="+mn-lt"/>
          <a:ea typeface="+mn-ea"/>
          <a:cs typeface="+mn-cs"/>
        </a:defRPr>
      </a:lvl6pPr>
      <a:lvl7pPr marL="3231833" indent="-248603" algn="l" defTabSz="994410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8" kern="1200">
          <a:solidFill>
            <a:schemeClr val="tx1"/>
          </a:solidFill>
          <a:latin typeface="+mn-lt"/>
          <a:ea typeface="+mn-ea"/>
          <a:cs typeface="+mn-cs"/>
        </a:defRPr>
      </a:lvl7pPr>
      <a:lvl8pPr marL="3729038" indent="-248603" algn="l" defTabSz="994410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8" kern="1200">
          <a:solidFill>
            <a:schemeClr val="tx1"/>
          </a:solidFill>
          <a:latin typeface="+mn-lt"/>
          <a:ea typeface="+mn-ea"/>
          <a:cs typeface="+mn-cs"/>
        </a:defRPr>
      </a:lvl8pPr>
      <a:lvl9pPr marL="4226243" indent="-248603" algn="l" defTabSz="994410" rtl="0" eaLnBrk="1" latinLnBrk="0" hangingPunct="1">
        <a:lnSpc>
          <a:spcPct val="90000"/>
        </a:lnSpc>
        <a:spcBef>
          <a:spcPts val="544"/>
        </a:spcBef>
        <a:buFont typeface="Arial" panose="020B0604020202020204" pitchFamily="34" charset="0"/>
        <a:buChar char="•"/>
        <a:defRPr sz="19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1pPr>
      <a:lvl2pPr marL="497205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2pPr>
      <a:lvl3pPr marL="994410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3pPr>
      <a:lvl4pPr marL="1491615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4pPr>
      <a:lvl5pPr marL="1988820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5pPr>
      <a:lvl6pPr marL="2486025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6pPr>
      <a:lvl7pPr marL="2983230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7pPr>
      <a:lvl8pPr marL="3480435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8pPr>
      <a:lvl9pPr marL="3977640" algn="l" defTabSz="994410" rtl="0" eaLnBrk="1" latinLnBrk="0" hangingPunct="1">
        <a:defRPr sz="19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g"/><Relationship Id="rId5" Type="http://schemas.openxmlformats.org/officeDocument/2006/relationships/image" Target="../media/image4.jpeg"/><Relationship Id="rId10" Type="http://schemas.openxmlformats.org/officeDocument/2006/relationships/image" Target="../media/image9.jp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2">
            <a:extLst>
              <a:ext uri="{FF2B5EF4-FFF2-40B4-BE49-F238E27FC236}">
                <a16:creationId xmlns:a16="http://schemas.microsoft.com/office/drawing/2014/main" xmlns="" id="{D0DE363D-8E2D-5C8B-CBB8-BDA490926F29}"/>
              </a:ext>
            </a:extLst>
          </p:cNvPr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787" y="3118379"/>
            <a:ext cx="2203683" cy="1519063"/>
          </a:xfrm>
          <a:prstGeom prst="rect">
            <a:avLst/>
          </a:prstGeom>
        </p:spPr>
      </p:pic>
      <p:pic>
        <p:nvPicPr>
          <p:cNvPr id="5" name="그림 46">
            <a:extLst>
              <a:ext uri="{FF2B5EF4-FFF2-40B4-BE49-F238E27FC236}">
                <a16:creationId xmlns:a16="http://schemas.microsoft.com/office/drawing/2014/main" xmlns="" id="{D07BF74E-0C41-37CF-F4E1-AD26696F5A74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8874706" y="707257"/>
            <a:ext cx="2203682" cy="1498799"/>
          </a:xfrm>
          <a:prstGeom prst="rect">
            <a:avLst/>
          </a:prstGeom>
        </p:spPr>
      </p:pic>
      <p:pic>
        <p:nvPicPr>
          <p:cNvPr id="6" name="그림 49">
            <a:extLst>
              <a:ext uri="{FF2B5EF4-FFF2-40B4-BE49-F238E27FC236}">
                <a16:creationId xmlns:a16="http://schemas.microsoft.com/office/drawing/2014/main" xmlns="" id="{1252F72A-FBF4-E8B9-3AC4-25E310BE9AE2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787" y="707257"/>
            <a:ext cx="2203683" cy="1519063"/>
          </a:xfrm>
          <a:prstGeom prst="rect">
            <a:avLst/>
          </a:prstGeom>
        </p:spPr>
      </p:pic>
      <p:pic>
        <p:nvPicPr>
          <p:cNvPr id="7" name="그림 50">
            <a:extLst>
              <a:ext uri="{FF2B5EF4-FFF2-40B4-BE49-F238E27FC236}">
                <a16:creationId xmlns:a16="http://schemas.microsoft.com/office/drawing/2014/main" xmlns="" id="{1A4670CB-C659-E944-A15A-36053063FE76}"/>
              </a:ext>
            </a:extLst>
          </p:cNvPr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4094" y="3118379"/>
            <a:ext cx="2203682" cy="1519063"/>
          </a:xfrm>
          <a:prstGeom prst="rect">
            <a:avLst/>
          </a:prstGeom>
        </p:spPr>
      </p:pic>
      <p:pic>
        <p:nvPicPr>
          <p:cNvPr id="8" name="그림 51">
            <a:extLst>
              <a:ext uri="{FF2B5EF4-FFF2-40B4-BE49-F238E27FC236}">
                <a16:creationId xmlns:a16="http://schemas.microsoft.com/office/drawing/2014/main" xmlns="" id="{DB711A15-F2D6-F625-92DB-CD05B380189A}"/>
              </a:ext>
            </a:extLst>
          </p:cNvPr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9400" y="716504"/>
            <a:ext cx="2203682" cy="1498799"/>
          </a:xfrm>
          <a:prstGeom prst="rect">
            <a:avLst/>
          </a:prstGeom>
        </p:spPr>
      </p:pic>
      <p:pic>
        <p:nvPicPr>
          <p:cNvPr id="9" name="그림 52">
            <a:extLst>
              <a:ext uri="{FF2B5EF4-FFF2-40B4-BE49-F238E27FC236}">
                <a16:creationId xmlns:a16="http://schemas.microsoft.com/office/drawing/2014/main" xmlns="" id="{921E32AB-1D15-E21E-90EB-E98759D03F26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8874706" y="3118378"/>
            <a:ext cx="2245306" cy="1535566"/>
          </a:xfrm>
          <a:prstGeom prst="rect">
            <a:avLst/>
          </a:prstGeom>
        </p:spPr>
      </p:pic>
      <p:graphicFrame>
        <p:nvGraphicFramePr>
          <p:cNvPr id="10" name="표 53">
            <a:extLst>
              <a:ext uri="{FF2B5EF4-FFF2-40B4-BE49-F238E27FC236}">
                <a16:creationId xmlns:a16="http://schemas.microsoft.com/office/drawing/2014/main" xmlns="" id="{8A4F6402-80A7-55C0-1A2E-6B3EA1313B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1457510"/>
              </p:ext>
            </p:extLst>
          </p:nvPr>
        </p:nvGraphicFramePr>
        <p:xfrm>
          <a:off x="2138788" y="2260360"/>
          <a:ext cx="2203682" cy="8099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3903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19779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2597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 Virtual</a:t>
                      </a:r>
                      <a:r>
                        <a:rPr lang="ko-KR" altLang="en-US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 </a:t>
                      </a:r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ennis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58396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Whole body movements-Attention, memory,  visual  &amp; auditory perception, reaction time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11" name="표 54">
            <a:extLst>
              <a:ext uri="{FF2B5EF4-FFF2-40B4-BE49-F238E27FC236}">
                <a16:creationId xmlns:a16="http://schemas.microsoft.com/office/drawing/2014/main" xmlns="" id="{336ECFB4-5894-C9A3-5564-EC4C938BC1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1907453"/>
              </p:ext>
            </p:extLst>
          </p:nvPr>
        </p:nvGraphicFramePr>
        <p:xfrm>
          <a:off x="4384094" y="2243582"/>
          <a:ext cx="2203682" cy="8099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9983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63699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2597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Find me (Objects recognition)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58396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Upper extremity movements- Attention, memory, ,  visual  &amp; auditory perception, reaction time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12" name="표 55">
            <a:extLst>
              <a:ext uri="{FF2B5EF4-FFF2-40B4-BE49-F238E27FC236}">
                <a16:creationId xmlns:a16="http://schemas.microsoft.com/office/drawing/2014/main" xmlns="" id="{776B38B8-65A2-5857-A1E7-2788A3B30A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0258791"/>
              </p:ext>
            </p:extLst>
          </p:nvPr>
        </p:nvGraphicFramePr>
        <p:xfrm>
          <a:off x="6629400" y="2243409"/>
          <a:ext cx="2203682" cy="8099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5262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38420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9008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Virtual goalkeeper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51986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Whole bod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Decision-making, calculation, attention, memory, reaction time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13" name="표 56">
            <a:extLst>
              <a:ext uri="{FF2B5EF4-FFF2-40B4-BE49-F238E27FC236}">
                <a16:creationId xmlns:a16="http://schemas.microsoft.com/office/drawing/2014/main" xmlns="" id="{0172E890-6BFA-6412-DE2A-5DBA7D7C2D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3610909"/>
              </p:ext>
            </p:extLst>
          </p:nvPr>
        </p:nvGraphicFramePr>
        <p:xfrm>
          <a:off x="8874706" y="2206054"/>
          <a:ext cx="2245306" cy="86726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2396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42910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8262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Virtual</a:t>
                      </a:r>
                      <a:r>
                        <a:rPr lang="ko-KR" altLang="en-US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 </a:t>
                      </a:r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soccer</a:t>
                      </a:r>
                      <a:r>
                        <a:rPr lang="ko-KR" altLang="en-US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 </a:t>
                      </a:r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striker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50648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Whole bod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Planning, calculation, attention, memory, reaction time, visual perception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14" name="표 57">
            <a:extLst>
              <a:ext uri="{FF2B5EF4-FFF2-40B4-BE49-F238E27FC236}">
                <a16:creationId xmlns:a16="http://schemas.microsoft.com/office/drawing/2014/main" xmlns="" id="{02CD88CC-9C1A-F8FC-2DCC-8763AB81EC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2599267"/>
              </p:ext>
            </p:extLst>
          </p:nvPr>
        </p:nvGraphicFramePr>
        <p:xfrm>
          <a:off x="2138787" y="4645219"/>
          <a:ext cx="2245308" cy="8847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8952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836356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2485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Virtual basketball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6598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Whole bod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Planning, memory, attention, reaction time, ,  visual  &amp; auditory perception, decision making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15" name="표 58">
            <a:extLst>
              <a:ext uri="{FF2B5EF4-FFF2-40B4-BE49-F238E27FC236}">
                <a16:creationId xmlns:a16="http://schemas.microsoft.com/office/drawing/2014/main" xmlns="" id="{C51FA801-A065-4E05-D007-BE4362A22D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3075055"/>
              </p:ext>
            </p:extLst>
          </p:nvPr>
        </p:nvGraphicFramePr>
        <p:xfrm>
          <a:off x="4384094" y="4638340"/>
          <a:ext cx="2231058" cy="8847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24044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807014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3497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Virtual</a:t>
                      </a:r>
                      <a:r>
                        <a:rPr lang="ko-KR" altLang="en-US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 </a:t>
                      </a:r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farm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64974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Whole bod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Planning, attention, memory, reaction time,  visual  &amp; auditory perception, decision making,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16" name="표 59">
            <a:extLst>
              <a:ext uri="{FF2B5EF4-FFF2-40B4-BE49-F238E27FC236}">
                <a16:creationId xmlns:a16="http://schemas.microsoft.com/office/drawing/2014/main" xmlns="" id="{6A6E58DF-44AB-3952-31F2-6F62274CFE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9422612"/>
              </p:ext>
            </p:extLst>
          </p:nvPr>
        </p:nvGraphicFramePr>
        <p:xfrm>
          <a:off x="6629400" y="4636320"/>
          <a:ext cx="2203682" cy="894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7133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86549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4969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Card memorize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6452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Upper extremity movements- attention, memory,  reaction time, ,  visual  &amp; auditory perception, decision making 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17" name="표 60">
            <a:extLst>
              <a:ext uri="{FF2B5EF4-FFF2-40B4-BE49-F238E27FC236}">
                <a16:creationId xmlns:a16="http://schemas.microsoft.com/office/drawing/2014/main" xmlns="" id="{F811D1D6-BE0A-3A69-A782-C3C519E0F9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2794353"/>
              </p:ext>
            </p:extLst>
          </p:nvPr>
        </p:nvGraphicFramePr>
        <p:xfrm>
          <a:off x="8874706" y="4628098"/>
          <a:ext cx="2245306" cy="8949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91033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54273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17133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Virtual car racing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57847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runk &amp; upper extremit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 Planning, calculation attention, memory, reaction time, ,  visual  &amp; auditory perception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pic>
        <p:nvPicPr>
          <p:cNvPr id="18" name="그림 33">
            <a:extLst>
              <a:ext uri="{FF2B5EF4-FFF2-40B4-BE49-F238E27FC236}">
                <a16:creationId xmlns:a16="http://schemas.microsoft.com/office/drawing/2014/main" xmlns="" id="{B958D4E8-1FAD-24B2-0758-3CD6E68FE93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4094" y="707256"/>
            <a:ext cx="2203682" cy="1519062"/>
          </a:xfrm>
          <a:prstGeom prst="rect">
            <a:avLst/>
          </a:prstGeom>
        </p:spPr>
      </p:pic>
      <p:pic>
        <p:nvPicPr>
          <p:cNvPr id="19" name="그림 42">
            <a:extLst>
              <a:ext uri="{FF2B5EF4-FFF2-40B4-BE49-F238E27FC236}">
                <a16:creationId xmlns:a16="http://schemas.microsoft.com/office/drawing/2014/main" xmlns="" id="{B67AC111-73B9-3A7C-4777-891CFA634BD7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9400" y="3118378"/>
            <a:ext cx="2203682" cy="1509466"/>
          </a:xfrm>
          <a:prstGeom prst="rect">
            <a:avLst/>
          </a:prstGeom>
        </p:spPr>
      </p:pic>
      <p:pic>
        <p:nvPicPr>
          <p:cNvPr id="2" name="object 21">
            <a:extLst>
              <a:ext uri="{FF2B5EF4-FFF2-40B4-BE49-F238E27FC236}">
                <a16:creationId xmlns:a16="http://schemas.microsoft.com/office/drawing/2014/main" xmlns="" id="{3A8C158D-CB1D-7065-66C7-F7B2A5D4489B}"/>
              </a:ext>
            </a:extLst>
          </p:cNvPr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4415669" y="5562048"/>
            <a:ext cx="2162059" cy="1498799"/>
          </a:xfrm>
          <a:prstGeom prst="rect">
            <a:avLst/>
          </a:prstGeom>
        </p:spPr>
      </p:pic>
      <p:pic>
        <p:nvPicPr>
          <p:cNvPr id="3" name="object 22">
            <a:extLst>
              <a:ext uri="{FF2B5EF4-FFF2-40B4-BE49-F238E27FC236}">
                <a16:creationId xmlns:a16="http://schemas.microsoft.com/office/drawing/2014/main" xmlns="" id="{5A5992B1-E8D6-6D99-3C14-9E2E1C0C12CA}"/>
              </a:ext>
            </a:extLst>
          </p:cNvPr>
          <p:cNvPicPr/>
          <p:nvPr/>
        </p:nvPicPr>
        <p:blipFill>
          <a:blip r:embed="rId11" cstate="print"/>
          <a:stretch>
            <a:fillRect/>
          </a:stretch>
        </p:blipFill>
        <p:spPr>
          <a:xfrm>
            <a:off x="2138787" y="5562048"/>
            <a:ext cx="2203681" cy="1484886"/>
          </a:xfrm>
          <a:prstGeom prst="rect">
            <a:avLst/>
          </a:prstGeom>
        </p:spPr>
      </p:pic>
      <p:pic>
        <p:nvPicPr>
          <p:cNvPr id="20" name="object 20">
            <a:extLst>
              <a:ext uri="{FF2B5EF4-FFF2-40B4-BE49-F238E27FC236}">
                <a16:creationId xmlns:a16="http://schemas.microsoft.com/office/drawing/2014/main" xmlns="" id="{0DE78A54-A0C1-BBF6-010D-50684CA6B6E8}"/>
              </a:ext>
            </a:extLst>
          </p:cNvPr>
          <p:cNvPicPr/>
          <p:nvPr/>
        </p:nvPicPr>
        <p:blipFill>
          <a:blip r:embed="rId12" cstate="print"/>
          <a:stretch>
            <a:fillRect/>
          </a:stretch>
        </p:blipFill>
        <p:spPr>
          <a:xfrm>
            <a:off x="6631411" y="5562047"/>
            <a:ext cx="2201671" cy="1498799"/>
          </a:xfrm>
          <a:prstGeom prst="rect">
            <a:avLst/>
          </a:prstGeom>
        </p:spPr>
      </p:pic>
      <p:pic>
        <p:nvPicPr>
          <p:cNvPr id="21" name="object 17">
            <a:extLst>
              <a:ext uri="{FF2B5EF4-FFF2-40B4-BE49-F238E27FC236}">
                <a16:creationId xmlns:a16="http://schemas.microsoft.com/office/drawing/2014/main" xmlns="" id="{9A467D22-2349-FEAF-8DB4-6CB02F72D5A9}"/>
              </a:ext>
            </a:extLst>
          </p:cNvPr>
          <p:cNvPicPr/>
          <p:nvPr/>
        </p:nvPicPr>
        <p:blipFill>
          <a:blip r:embed="rId13" cstate="print"/>
          <a:stretch>
            <a:fillRect/>
          </a:stretch>
        </p:blipFill>
        <p:spPr>
          <a:xfrm>
            <a:off x="8886764" y="5579068"/>
            <a:ext cx="2191623" cy="1481778"/>
          </a:xfrm>
          <a:prstGeom prst="rect">
            <a:avLst/>
          </a:prstGeom>
        </p:spPr>
      </p:pic>
      <p:graphicFrame>
        <p:nvGraphicFramePr>
          <p:cNvPr id="22" name="표 57">
            <a:extLst>
              <a:ext uri="{FF2B5EF4-FFF2-40B4-BE49-F238E27FC236}">
                <a16:creationId xmlns:a16="http://schemas.microsoft.com/office/drawing/2014/main" xmlns="" id="{5FB80A9B-6666-6415-75B6-2786DAF43E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0090298"/>
              </p:ext>
            </p:extLst>
          </p:nvPr>
        </p:nvGraphicFramePr>
        <p:xfrm>
          <a:off x="2148544" y="7064118"/>
          <a:ext cx="2192344" cy="8847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4027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28317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2485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Orientations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6598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Upper extremit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Orientation, memory, planning, attention, reaction time, visual  perception, decision making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23" name="표 57">
            <a:extLst>
              <a:ext uri="{FF2B5EF4-FFF2-40B4-BE49-F238E27FC236}">
                <a16:creationId xmlns:a16="http://schemas.microsoft.com/office/drawing/2014/main" xmlns="" id="{0A252C59-AE64-EB8E-81BE-BFD48312F8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36924111"/>
              </p:ext>
            </p:extLst>
          </p:nvPr>
        </p:nvGraphicFramePr>
        <p:xfrm>
          <a:off x="4384094" y="7076830"/>
          <a:ext cx="2192344" cy="8847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4027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28317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2485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Play with numbers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6598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Upper extremit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Calculation, memory, planning, attention, reaction time, visual  perception, decision making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24" name="표 57">
            <a:extLst>
              <a:ext uri="{FF2B5EF4-FFF2-40B4-BE49-F238E27FC236}">
                <a16:creationId xmlns:a16="http://schemas.microsoft.com/office/drawing/2014/main" xmlns="" id="{1C0C4F53-5DE9-FAF0-D0B9-167B59D089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4106383"/>
              </p:ext>
            </p:extLst>
          </p:nvPr>
        </p:nvGraphicFramePr>
        <p:xfrm>
          <a:off x="6629400" y="7091613"/>
          <a:ext cx="2192344" cy="8847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4027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28317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2485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umbers make sense (Trail making)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6598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Upper extremit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Memory, planning, attention, reaction time, visual  perception, decision making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graphicFrame>
        <p:nvGraphicFramePr>
          <p:cNvPr id="25" name="표 57">
            <a:extLst>
              <a:ext uri="{FF2B5EF4-FFF2-40B4-BE49-F238E27FC236}">
                <a16:creationId xmlns:a16="http://schemas.microsoft.com/office/drawing/2014/main" xmlns="" id="{CCDA3034-6706-5536-18FF-32A498A0A2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4311628"/>
              </p:ext>
            </p:extLst>
          </p:nvPr>
        </p:nvGraphicFramePr>
        <p:xfrm>
          <a:off x="8880375" y="7076829"/>
          <a:ext cx="2192344" cy="8847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64027">
                  <a:extLst>
                    <a:ext uri="{9D8B030D-6E8A-4147-A177-3AD203B41FA5}">
                      <a16:colId xmlns:a16="http://schemas.microsoft.com/office/drawing/2014/main" xmlns="" val="2019930696"/>
                    </a:ext>
                  </a:extLst>
                </a:gridCol>
                <a:gridCol w="1728317">
                  <a:extLst>
                    <a:ext uri="{9D8B030D-6E8A-4147-A177-3AD203B41FA5}">
                      <a16:colId xmlns:a16="http://schemas.microsoft.com/office/drawing/2014/main" xmlns="" val="4123810290"/>
                    </a:ext>
                  </a:extLst>
                </a:gridCol>
              </a:tblGrid>
              <a:tr h="22485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Name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My house</a:t>
                      </a: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555082"/>
                  </a:ext>
                </a:extLst>
              </a:tr>
              <a:tr h="6598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Target</a:t>
                      </a:r>
                      <a:endParaRPr lang="ko-KR" altLang="en-US" sz="900" b="1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Whole body movements-</a:t>
                      </a:r>
                    </a:p>
                    <a:p>
                      <a:pPr latinLnBrk="1"/>
                      <a:r>
                        <a:rPr lang="en-US" altLang="ko-KR" sz="900" b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Visual  &amp; auditory perception, planning, memory, attention, reaction time, decision making</a:t>
                      </a:r>
                      <a:endParaRPr lang="ko-KR" altLang="en-US" sz="900" b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</a:endParaRPr>
                    </a:p>
                  </a:txBody>
                  <a:tcPr marL="47916" marR="47916" marT="18000" marB="18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04426325"/>
                  </a:ext>
                </a:extLst>
              </a:tr>
            </a:tbl>
          </a:graphicData>
        </a:graphic>
      </p:graphicFrame>
      <p:sp>
        <p:nvSpPr>
          <p:cNvPr id="26" name="ZoneTexte 25">
            <a:extLst>
              <a:ext uri="{FF2B5EF4-FFF2-40B4-BE49-F238E27FC236}">
                <a16:creationId xmlns:a16="http://schemas.microsoft.com/office/drawing/2014/main" xmlns="" id="{84B93149-10E7-E11F-AEDB-4C71264994E6}"/>
              </a:ext>
            </a:extLst>
          </p:cNvPr>
          <p:cNvSpPr txBox="1"/>
          <p:nvPr/>
        </p:nvSpPr>
        <p:spPr>
          <a:xfrm>
            <a:off x="5023967" y="120746"/>
            <a:ext cx="310494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Palatino Linotype" panose="02040502050505030304" pitchFamily="18" charset="0"/>
              </a:rPr>
              <a:t>Selected game contents</a:t>
            </a:r>
          </a:p>
        </p:txBody>
      </p:sp>
    </p:spTree>
    <p:extLst>
      <p:ext uri="{BB962C8B-B14F-4D97-AF65-F5344CB8AC3E}">
        <p14:creationId xmlns:p14="http://schemas.microsoft.com/office/powerpoint/2010/main" val="29170882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273</Words>
  <Application>Microsoft Office PowerPoint</Application>
  <PresentationFormat>사용자 지정</PresentationFormat>
  <Paragraphs>58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Thème Office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ekar Daekook</dc:creator>
  <cp:lastModifiedBy>Windows User</cp:lastModifiedBy>
  <cp:revision>6</cp:revision>
  <dcterms:created xsi:type="dcterms:W3CDTF">2022-09-21T08:28:28Z</dcterms:created>
  <dcterms:modified xsi:type="dcterms:W3CDTF">2022-09-25T05:15:02Z</dcterms:modified>
</cp:coreProperties>
</file>